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D15598-E6AE-467C-AD38-BCBB3AF5D0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ACCD34-889A-4428-AEAD-64EB66F811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838B5-4189-42E5-B154-49D5A3393E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5479C3-7385-48BE-BBE1-26A2325F7D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A1E177-5E12-4B55-90BB-8BD3F2717E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6C47F-9EC2-47A0-9BE3-E55BC3C2BE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8B8ED-C1D0-49CA-8325-BCAFC6DC8D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F7955B-33EF-461C-80E6-C28B1C5D84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F892F-64BA-48C5-9BE1-C08A0AA641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0574D-38AF-44DB-B080-BF20622E12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FA62F5-B528-4A08-B22E-88BB263E80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07C46-497E-40FC-9409-3D18474E2E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8601A7-2915-4025-9D03-6A24C4402D3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0"/>
          <p:cNvSpPr/>
          <p:nvPr/>
        </p:nvSpPr>
        <p:spPr>
          <a:xfrm>
            <a:off x="1149480" y="3471840"/>
            <a:ext cx="685800" cy="51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 rtl="1">
              <a:lnSpc>
                <a:spcPct val="100000"/>
              </a:lnSpc>
              <a:spcBef>
                <a:spcPts val="17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1"/>
          <p:cNvSpPr/>
          <p:nvPr/>
        </p:nvSpPr>
        <p:spPr>
          <a:xfrm rot="16200000">
            <a:off x="-1812960" y="3246480"/>
            <a:ext cx="487512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lnSpc>
                <a:spcPct val="7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CL2 Extracellular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 rtl="1">
              <a:lnSpc>
                <a:spcPct val="7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Expression (pg/10</a:t>
            </a:r>
            <a:r>
              <a:rPr b="1" lang="en-US" sz="900" spc="-1" strike="noStrike" baseline="30000">
                <a:solidFill>
                  <a:srgbClr val="000000"/>
                </a:solidFill>
                <a:latin typeface="Arial"/>
              </a:rPr>
              <a:t>7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cells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22"/>
          <p:cNvSpPr/>
          <p:nvPr/>
        </p:nvSpPr>
        <p:spPr>
          <a:xfrm>
            <a:off x="1620720" y="4240080"/>
            <a:ext cx="172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L-1β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pg/m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Object 25"/>
          <p:cNvGraphicFramePr/>
          <p:nvPr/>
        </p:nvGraphicFramePr>
        <p:xfrm>
          <a:off x="5437080" y="2523960"/>
          <a:ext cx="3095640" cy="17956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5" name="Object 2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437080" y="2523960"/>
                    <a:ext cx="3095640" cy="1795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Text Box 26"/>
          <p:cNvSpPr/>
          <p:nvPr/>
        </p:nvSpPr>
        <p:spPr>
          <a:xfrm rot="16200000">
            <a:off x="3590640" y="3254400"/>
            <a:ext cx="328464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lnSpc>
                <a:spcPct val="7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CL2 Extracellular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 rtl="1">
              <a:lnSpc>
                <a:spcPct val="7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Expression (pg/10</a:t>
            </a:r>
            <a:r>
              <a:rPr b="1" lang="en-US" sz="900" spc="-1" strike="noStrike" baseline="30000">
                <a:solidFill>
                  <a:srgbClr val="000000"/>
                </a:solidFill>
                <a:latin typeface="Arial"/>
              </a:rPr>
              <a:t>7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cells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Object 63" descr=""/>
          <p:cNvPicPr/>
          <p:nvPr/>
        </p:nvPicPr>
        <p:blipFill>
          <a:blip r:embed="rId3"/>
          <a:stretch/>
        </p:blipFill>
        <p:spPr>
          <a:xfrm>
            <a:off x="806400" y="2643120"/>
            <a:ext cx="3786120" cy="1584360"/>
          </a:xfrm>
          <a:prstGeom prst="rect">
            <a:avLst/>
          </a:prstGeom>
          <a:ln w="0">
            <a:noFill/>
          </a:ln>
        </p:spPr>
      </p:pic>
      <p:sp>
        <p:nvSpPr>
          <p:cNvPr id="48" name="Text Box 24"/>
          <p:cNvSpPr/>
          <p:nvPr/>
        </p:nvSpPr>
        <p:spPr>
          <a:xfrm>
            <a:off x="1328760" y="4052880"/>
            <a:ext cx="504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-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          80        500       300        500      2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64"/>
          <p:cNvSpPr/>
          <p:nvPr/>
        </p:nvSpPr>
        <p:spPr>
          <a:xfrm>
            <a:off x="3021120" y="4240080"/>
            <a:ext cx="172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 rtl="1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NF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U/ml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Group 13"/>
          <p:cNvGrpSpPr/>
          <p:nvPr/>
        </p:nvGrpSpPr>
        <p:grpSpPr>
          <a:xfrm>
            <a:off x="3170160" y="4129200"/>
            <a:ext cx="1295640" cy="144360"/>
            <a:chOff x="3170160" y="4129200"/>
            <a:chExt cx="1295640" cy="144360"/>
          </a:xfrm>
        </p:grpSpPr>
        <p:sp>
          <p:nvSpPr>
            <p:cNvPr id="51" name="Line 14"/>
            <p:cNvSpPr/>
            <p:nvPr/>
          </p:nvSpPr>
          <p:spPr>
            <a:xfrm>
              <a:off x="3170160" y="4273560"/>
              <a:ext cx="129564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5"/>
            <p:cNvSpPr/>
            <p:nvPr/>
          </p:nvSpPr>
          <p:spPr>
            <a:xfrm>
              <a:off x="3170160" y="4129200"/>
              <a:ext cx="0" cy="144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6"/>
            <p:cNvSpPr/>
            <p:nvPr/>
          </p:nvSpPr>
          <p:spPr>
            <a:xfrm>
              <a:off x="4465800" y="4129200"/>
              <a:ext cx="0" cy="144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" name="Group 17"/>
          <p:cNvGrpSpPr/>
          <p:nvPr/>
        </p:nvGrpSpPr>
        <p:grpSpPr>
          <a:xfrm>
            <a:off x="1803240" y="4129200"/>
            <a:ext cx="1222560" cy="144360"/>
            <a:chOff x="1803240" y="4129200"/>
            <a:chExt cx="1222560" cy="144360"/>
          </a:xfrm>
        </p:grpSpPr>
        <p:sp>
          <p:nvSpPr>
            <p:cNvPr id="55" name="Line 18"/>
            <p:cNvSpPr/>
            <p:nvPr/>
          </p:nvSpPr>
          <p:spPr>
            <a:xfrm>
              <a:off x="1803240" y="4273560"/>
              <a:ext cx="1222560" cy="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9"/>
            <p:cNvSpPr/>
            <p:nvPr/>
          </p:nvSpPr>
          <p:spPr>
            <a:xfrm>
              <a:off x="1803240" y="4129200"/>
              <a:ext cx="0" cy="144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0"/>
            <p:cNvSpPr/>
            <p:nvPr/>
          </p:nvSpPr>
          <p:spPr>
            <a:xfrm>
              <a:off x="3025800" y="4129200"/>
              <a:ext cx="0" cy="144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Text Box 65"/>
          <p:cNvSpPr/>
          <p:nvPr/>
        </p:nvSpPr>
        <p:spPr>
          <a:xfrm>
            <a:off x="1812960" y="357336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66"/>
          <p:cNvSpPr/>
          <p:nvPr/>
        </p:nvSpPr>
        <p:spPr>
          <a:xfrm>
            <a:off x="2286000" y="357336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67"/>
          <p:cNvSpPr/>
          <p:nvPr/>
        </p:nvSpPr>
        <p:spPr>
          <a:xfrm>
            <a:off x="2743200" y="292428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68"/>
          <p:cNvSpPr/>
          <p:nvPr/>
        </p:nvSpPr>
        <p:spPr>
          <a:xfrm>
            <a:off x="3219480" y="334980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69"/>
          <p:cNvSpPr/>
          <p:nvPr/>
        </p:nvSpPr>
        <p:spPr>
          <a:xfrm>
            <a:off x="3692520" y="3225960"/>
            <a:ext cx="36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70"/>
          <p:cNvSpPr/>
          <p:nvPr/>
        </p:nvSpPr>
        <p:spPr>
          <a:xfrm>
            <a:off x="4125960" y="2708280"/>
            <a:ext cx="71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72"/>
          <p:cNvSpPr/>
          <p:nvPr/>
        </p:nvSpPr>
        <p:spPr>
          <a:xfrm>
            <a:off x="6046920" y="4040280"/>
            <a:ext cx="50403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-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                IL-1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NF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br>
              <a:rPr sz="1000"/>
            </a:b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         500 pg/ml          2000 U/m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73"/>
          <p:cNvSpPr/>
          <p:nvPr/>
        </p:nvSpPr>
        <p:spPr>
          <a:xfrm>
            <a:off x="6939000" y="3567240"/>
            <a:ext cx="71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74"/>
          <p:cNvSpPr/>
          <p:nvPr/>
        </p:nvSpPr>
        <p:spPr>
          <a:xfrm>
            <a:off x="7854840" y="2708280"/>
            <a:ext cx="71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77"/>
          <p:cNvSpPr/>
          <p:nvPr/>
        </p:nvSpPr>
        <p:spPr>
          <a:xfrm>
            <a:off x="390600" y="2205000"/>
            <a:ext cx="1085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. T47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91"/>
          <p:cNvSpPr/>
          <p:nvPr/>
        </p:nvSpPr>
        <p:spPr>
          <a:xfrm>
            <a:off x="5013360" y="2205000"/>
            <a:ext cx="998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. MCF-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14T07:51:00Z</dcterms:created>
  <dc:creator>aditbnb</dc:creator>
  <dc:description/>
  <dc:language>en-US</dc:language>
  <cp:lastModifiedBy>AditBNB1</cp:lastModifiedBy>
  <dcterms:modified xsi:type="dcterms:W3CDTF">2011-03-30T06:52:12Z</dcterms:modified>
  <cp:revision>128</cp:revision>
  <dc:subject/>
  <dc:title>Slide 1</dc:title>
</cp:coreProperties>
</file>